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9" r:id="rId2"/>
  </p:sldIdLst>
  <p:sldSz cx="6858000" cy="9906000" type="A4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352" autoAdjust="0"/>
    <p:restoredTop sz="96247" autoAdjust="0"/>
  </p:normalViewPr>
  <p:slideViewPr>
    <p:cSldViewPr snapToGrid="0">
      <p:cViewPr varScale="1">
        <p:scale>
          <a:sx n="77" d="100"/>
          <a:sy n="77" d="100"/>
        </p:scale>
        <p:origin x="3510" y="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37FEF0-7CAB-432B-A1C8-95A08DA7ECAE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1734DF-5F11-4274-A00D-0BA1A80B1E8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327102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Table 3: Modulation of genes of interest in DN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A1734DF-5F11-4274-A00D-0BA1A80B1E8D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73365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3052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0479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07633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39116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99909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6593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51030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94636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00058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14052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0722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E8176C-05BB-41EC-A966-3A5842D5082D}" type="datetimeFigureOut">
              <a:rPr lang="en-GB" smtClean="0"/>
              <a:t>05/09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79D6FD-7A1B-4D6E-86C2-B55F86E55EB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6467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20970B06-5553-445E-8E58-4BCA86061AC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0920986"/>
              </p:ext>
            </p:extLst>
          </p:nvPr>
        </p:nvGraphicFramePr>
        <p:xfrm>
          <a:off x="386426" y="1074858"/>
          <a:ext cx="5915025" cy="1721513"/>
        </p:xfrm>
        <a:graphic>
          <a:graphicData uri="http://schemas.openxmlformats.org/drawingml/2006/table">
            <a:tbl>
              <a:tblPr firstRow="1" firstCol="1" bandRow="1"/>
              <a:tblGrid>
                <a:gridCol w="791952">
                  <a:extLst>
                    <a:ext uri="{9D8B030D-6E8A-4147-A177-3AD203B41FA5}">
                      <a16:colId xmlns:a16="http://schemas.microsoft.com/office/drawing/2014/main" val="2670756885"/>
                    </a:ext>
                  </a:extLst>
                </a:gridCol>
                <a:gridCol w="2952839">
                  <a:extLst>
                    <a:ext uri="{9D8B030D-6E8A-4147-A177-3AD203B41FA5}">
                      <a16:colId xmlns:a16="http://schemas.microsoft.com/office/drawing/2014/main" val="2417712135"/>
                    </a:ext>
                  </a:extLst>
                </a:gridCol>
                <a:gridCol w="2170234">
                  <a:extLst>
                    <a:ext uri="{9D8B030D-6E8A-4147-A177-3AD203B41FA5}">
                      <a16:colId xmlns:a16="http://schemas.microsoft.com/office/drawing/2014/main" val="4253085145"/>
                    </a:ext>
                  </a:extLst>
                </a:gridCol>
              </a:tblGrid>
              <a:tr h="19203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Genes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b="1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xpression Suite software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1200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−ΔΔ</a:t>
                      </a:r>
                      <a:r>
                        <a:rPr lang="en-GB" sz="1200" i="1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T</a:t>
                      </a:r>
                      <a:r>
                        <a:rPr lang="en-GB" sz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US" sz="12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ethod followed by</a:t>
                      </a:r>
                      <a:r>
                        <a:rPr lang="en-US" sz="1200" b="1" i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 t </a:t>
                      </a:r>
                      <a:r>
                        <a:rPr lang="en-US" sz="1200" b="1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test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38791546"/>
                  </a:ext>
                </a:extLst>
              </a:tr>
              <a:tr h="19203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DC1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↑2.5 fold, *p= 0.02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↑2.6 fold, **p= 0.002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7152475"/>
                  </a:ext>
                </a:extLst>
              </a:tr>
              <a:tr h="19203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DC2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↑1.0 fold, p= 0.80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↑1.1 fold, p=0.82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7702124"/>
                  </a:ext>
                </a:extLst>
              </a:tr>
              <a:tr h="19203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DC3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↑2.4 fold, **p= 0.006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↑2.4 fold, **p 0.001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7417818"/>
                  </a:ext>
                </a:extLst>
              </a:tr>
              <a:tr h="19203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DC4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↑1.5 fold, *p=0.032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↑1.6 fold, *p 0.039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547000"/>
                  </a:ext>
                </a:extLst>
              </a:tr>
              <a:tr h="19203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MP2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↑6.5 fold, p=0.24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↑8.3 fold, p=0.11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06450505"/>
                  </a:ext>
                </a:extLst>
              </a:tr>
              <a:tr h="19203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MP9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↑1.0 fold, p=0.40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↑1.0 fold, p=0.97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047286"/>
                  </a:ext>
                </a:extLst>
              </a:tr>
              <a:tr h="19203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MP14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↑2.2 fold, **p=0.009</a:t>
                      </a:r>
                      <a:endParaRPr lang="en-GB" sz="11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200" kern="12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↑2.2 fold, **p=0.008</a:t>
                      </a:r>
                      <a:endParaRPr lang="en-GB" sz="11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7294" marR="6729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8397392"/>
                  </a:ext>
                </a:extLst>
              </a:tr>
            </a:tbl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AFE03319-6D38-4F2B-BF67-DF439EE80600}"/>
              </a:ext>
            </a:extLst>
          </p:cNvPr>
          <p:cNvSpPr/>
          <p:nvPr/>
        </p:nvSpPr>
        <p:spPr>
          <a:xfrm>
            <a:off x="248203" y="2916335"/>
            <a:ext cx="6122358" cy="151240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able S2: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wo complementary methods were used to analyse the qPCR array dat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Expression Suite software and 2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−ΔΔCT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ethod followed by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 t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est were used to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s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he array data and both methods showed a significant increase in SDC1, 3, 4 and MMP14 mRNA expression amongst other significantly modulated gene expression.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07B2804-CA9A-487E-AFDE-6C83A24B2C30}"/>
              </a:ext>
            </a:extLst>
          </p:cNvPr>
          <p:cNvSpPr txBox="1"/>
          <p:nvPr/>
        </p:nvSpPr>
        <p:spPr>
          <a:xfrm>
            <a:off x="248203" y="601664"/>
            <a:ext cx="21013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Table S2</a:t>
            </a:r>
          </a:p>
        </p:txBody>
      </p:sp>
    </p:spTree>
    <p:extLst>
      <p:ext uri="{BB962C8B-B14F-4D97-AF65-F5344CB8AC3E}">
        <p14:creationId xmlns:p14="http://schemas.microsoft.com/office/powerpoint/2010/main" val="16955738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5767</TotalTime>
  <Words>190</Words>
  <Application>Microsoft Office PowerPoint</Application>
  <PresentationFormat>A4 Paper (210x297 mm)</PresentationFormat>
  <Paragraphs>2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1_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ina Ramnath</dc:creator>
  <cp:lastModifiedBy>Raina Ramnath</cp:lastModifiedBy>
  <cp:revision>661</cp:revision>
  <cp:lastPrinted>2018-11-05T10:42:07Z</cp:lastPrinted>
  <dcterms:created xsi:type="dcterms:W3CDTF">2018-02-07T14:08:32Z</dcterms:created>
  <dcterms:modified xsi:type="dcterms:W3CDTF">2019-09-05T13:47:27Z</dcterms:modified>
</cp:coreProperties>
</file>